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0884D2-4DFE-4954-82D7-05F122170A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8ABF1B-DE9A-40F1-A63F-1D21652B3A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2E5B4F-D280-4542-81ED-31CC293798B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A68DA6-B7A8-4589-9E91-A5EB1FC34F0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06375A-0621-4F2A-A49E-8814AB56C3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5BE37E-2DA0-44E2-8670-F6582AB3AF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8B1521-3C6C-49DA-AD84-03B42792D6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B3C078-AD3D-41A4-A971-FCDD0CAE46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D1B9EC-C451-4213-AB9A-E851B1BE4B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88BD9E-809A-451F-A2F5-97E0AC6806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32C140-E7CA-496F-9ABE-FCD04618EC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CE3CCB-93A7-47CC-8E5C-6F76A93E49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417032-833A-487E-B514-D5DEF4D04A3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5"/>
          <p:cNvSpPr/>
          <p:nvPr/>
        </p:nvSpPr>
        <p:spPr>
          <a:xfrm>
            <a:off x="228600" y="533520"/>
            <a:ext cx="480060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7"/>
          <p:cNvSpPr/>
          <p:nvPr/>
        </p:nvSpPr>
        <p:spPr>
          <a:xfrm>
            <a:off x="609480" y="457200"/>
            <a:ext cx="5639040" cy="3808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hree BAC libraries from 3 sex types with different enzyme diges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0"/>
          <p:cNvSpPr/>
          <p:nvPr/>
        </p:nvSpPr>
        <p:spPr>
          <a:xfrm>
            <a:off x="609480" y="1219320"/>
            <a:ext cx="5639040" cy="3808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nitial library screening through hybridization or PCR of 3-D pool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11"/>
          <p:cNvSpPr/>
          <p:nvPr/>
        </p:nvSpPr>
        <p:spPr>
          <a:xfrm>
            <a:off x="457200" y="1981080"/>
            <a:ext cx="5943600" cy="381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olony PCR to confirm each picked positive clone from library screen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2"/>
          <p:cNvSpPr/>
          <p:nvPr/>
        </p:nvSpPr>
        <p:spPr>
          <a:xfrm>
            <a:off x="228600" y="2743200"/>
            <a:ext cx="6400800" cy="533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Refer to fingerprint map, insert sizes, and cross amplification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PMingLiU"/>
              </a:rPr>
              <a:t>among all the PC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PMingLiU"/>
              </a:rPr>
              <a:t>confirmed positives for further confirmation and configuration of the orient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13"/>
          <p:cNvSpPr/>
          <p:nvPr/>
        </p:nvSpPr>
        <p:spPr>
          <a:xfrm>
            <a:off x="609480" y="3657600"/>
            <a:ext cx="5639040" cy="533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PMingLiU"/>
              </a:rPr>
              <a:t>Sequencing the cross amplified PCR products between the seed an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PMingLiU"/>
              </a:rPr>
              <a:t>extended candidate BAC clones to check the specificity of overlapp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14"/>
          <p:cNvSpPr/>
          <p:nvPr/>
        </p:nvSpPr>
        <p:spPr>
          <a:xfrm>
            <a:off x="304920" y="4572000"/>
            <a:ext cx="6248160" cy="3808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PMingLiU"/>
              </a:rPr>
              <a:t>Check the male-specificity of the end sequence of the most extended clo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5"/>
          <p:cNvSpPr/>
          <p:nvPr/>
        </p:nvSpPr>
        <p:spPr>
          <a:xfrm>
            <a:off x="380880" y="5334120"/>
            <a:ext cx="6096240" cy="3808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PMingLiU"/>
              </a:rPr>
              <a:t>FISH to confirm the extended candidate clone for its localization within MS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17"/>
          <p:cNvSpPr/>
          <p:nvPr/>
        </p:nvSpPr>
        <p:spPr>
          <a:xfrm>
            <a:off x="3352680" y="838080"/>
            <a:ext cx="0" cy="3812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20"/>
          <p:cNvSpPr/>
          <p:nvPr/>
        </p:nvSpPr>
        <p:spPr>
          <a:xfrm>
            <a:off x="3352680" y="4952880"/>
            <a:ext cx="0" cy="3812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21"/>
          <p:cNvSpPr/>
          <p:nvPr/>
        </p:nvSpPr>
        <p:spPr>
          <a:xfrm>
            <a:off x="3352680" y="4191120"/>
            <a:ext cx="0" cy="380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22"/>
          <p:cNvSpPr/>
          <p:nvPr/>
        </p:nvSpPr>
        <p:spPr>
          <a:xfrm>
            <a:off x="3352680" y="3276720"/>
            <a:ext cx="0" cy="380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23"/>
          <p:cNvSpPr/>
          <p:nvPr/>
        </p:nvSpPr>
        <p:spPr>
          <a:xfrm>
            <a:off x="3352680" y="2362320"/>
            <a:ext cx="0" cy="380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24"/>
          <p:cNvSpPr/>
          <p:nvPr/>
        </p:nvSpPr>
        <p:spPr>
          <a:xfrm>
            <a:off x="3352680" y="1600200"/>
            <a:ext cx="0" cy="380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07T22:17:47Z</dcterms:created>
  <dc:creator>Jianping</dc:creator>
  <dc:description/>
  <dc:language>en-US</dc:language>
  <cp:lastModifiedBy>Ray Ming</cp:lastModifiedBy>
  <dcterms:modified xsi:type="dcterms:W3CDTF">2011-08-05T23:18:16Z</dcterms:modified>
  <cp:revision>10</cp:revision>
  <dc:subject/>
  <dc:title>Slide 1</dc:title>
</cp:coreProperties>
</file>